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24" autoAdjust="0"/>
    <p:restoredTop sz="96405"/>
  </p:normalViewPr>
  <p:slideViewPr>
    <p:cSldViewPr snapToGrid="0">
      <p:cViewPr varScale="1">
        <p:scale>
          <a:sx n="151" d="100"/>
          <a:sy n="151" d="100"/>
        </p:scale>
        <p:origin x="2672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764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7404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4726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789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6977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0807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4622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5089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0509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4005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058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7057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ZoneTexte 149">
            <a:extLst>
              <a:ext uri="{FF2B5EF4-FFF2-40B4-BE49-F238E27FC236}">
                <a16:creationId xmlns:a16="http://schemas.microsoft.com/office/drawing/2014/main" id="{F540D0ED-8C63-DBB5-6638-1E4495D5B51F}"/>
              </a:ext>
            </a:extLst>
          </p:cNvPr>
          <p:cNvSpPr txBox="1"/>
          <p:nvPr/>
        </p:nvSpPr>
        <p:spPr>
          <a:xfrm>
            <a:off x="148382" y="8316001"/>
            <a:ext cx="6616835" cy="144655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verification of </a:t>
            </a:r>
            <a:r>
              <a:rPr lang="en-US" sz="11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100" b="1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-Crt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-Crt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ids in </a:t>
            </a:r>
            <a:r>
              <a:rPr lang="en-US" sz="1100" b="1" i="1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C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</a:p>
          <a:p>
            <a:pPr algn="just"/>
            <a:r>
              <a:rPr lang="en-US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chematic representation of the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 plasmids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ng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ong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iangle)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tic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eron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ing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(FS) and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ther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tE6803 or CrtE7002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BS (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all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eu rectangle) stands for ribosome binding site. </a:t>
            </a:r>
            <a:r>
              <a:rPr lang="fr-FR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elevant parts of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fied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ropriate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fr-FR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ing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monene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(LS)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ther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tE6803 or CrtE7002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elevant part of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. </a:t>
            </a:r>
            <a:r>
              <a:rPr lang="en-US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 marker </a:t>
            </a:r>
            <a:r>
              <a:rPr lang="en-US" sz="11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M) = </a:t>
            </a:r>
            <a:r>
              <a:rPr lang="fr-FR" sz="11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ick-Load</a:t>
            </a:r>
            <a:r>
              <a:rPr lang="fr-FR" sz="11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kb Plus DNA Ladder (NEB). </a:t>
            </a:r>
            <a:endParaRPr lang="fr-FR" sz="11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BBC0C909-5ED4-3DD5-E2C0-DB08DA7033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00" y="69468"/>
            <a:ext cx="6819900" cy="807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73548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2</TotalTime>
  <Words>132</Words>
  <Application>Microsoft Macintosh PowerPoint</Application>
  <PresentationFormat>Format A4 (210 x 297 mm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ne Vincent</dc:creator>
  <cp:lastModifiedBy>Franck Chauvat</cp:lastModifiedBy>
  <cp:revision>46</cp:revision>
  <dcterms:created xsi:type="dcterms:W3CDTF">2023-10-08T21:06:11Z</dcterms:created>
  <dcterms:modified xsi:type="dcterms:W3CDTF">2023-11-14T14:32:38Z</dcterms:modified>
</cp:coreProperties>
</file>